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3291E-3D8A-4904-83E0-7B9A8E8CF5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CAEB1-7AAA-4072-BBCE-E22008C8F3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65EBD8-D186-432D-9EFF-5E627CFE52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75FB9-DE01-4D76-8B98-A543283F00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010FF-62DF-4DE9-A142-1BC19CCAEE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CCD58-9A5A-42C5-9C2F-E0B292B477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ECAA8-2EA2-4C4F-A63E-4CE98EBCE5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9B5C0-6BD9-4273-9605-0018795ADA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F2B49-8994-44C2-9FAE-64677EBA4C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D5CBCF-9950-48F8-BF28-2B17BEF48A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C62EE-9469-4495-AC52-2B5F8DBBE6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DF69B-5AD2-4C45-B26B-BDD41292B7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62D4AA-5FE8-4A23-ADAA-C02E77AF49A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darwin.phyloviz.net/ComparingPartitions/index.php?link=Tool" TargetMode="Externa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84040" y="3662640"/>
            <a:ext cx="857592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5. Graphical representation of the concordance between the different partition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djusted Wallace coefficients were calculated using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the online tool available at: </a:t>
            </a:r>
            <a:r>
              <a:rPr b="0" lang="en-GB" sz="1800" spc="-1" strike="noStrike" u="sng">
                <a:solidFill>
                  <a:srgbClr val="009999"/>
                </a:solidFill>
                <a:uFillTx/>
                <a:latin typeface="Arial"/>
                <a:hlinkClick r:id="rId1"/>
              </a:rPr>
              <a:t>http://darwin.phyloviz.net/ComparingPartitions/index.php?link=Tool</a:t>
            </a:r>
            <a:r>
              <a:rPr b="0" lang="en-GB" sz="1800" spc="-1" strike="noStrike">
                <a:solidFill>
                  <a:srgbClr val="333399"/>
                </a:solidFill>
                <a:latin typeface="Arial"/>
              </a:rPr>
              <a:t>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Arial"/>
              </a:rPr>
              <a:t>A. phagocytophilum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 strains from ticks were excluded. Only typeable strains with data for all partitions were included (n = 247). The clonal complex as partition was excluded, because only 223 of 383 strains were part of a clonal complex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Only relationships with values &gt; 0.60 are shown. The thickness of the arrows represents the strength of the correl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2"/>
          <a:srcRect l="1205" t="14307" r="51005" b="42343"/>
          <a:stretch/>
        </p:blipFill>
        <p:spPr>
          <a:xfrm>
            <a:off x="2336760" y="527040"/>
            <a:ext cx="4470480" cy="2973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2T18:45:41Z</dcterms:created>
  <dc:creator>Friederike von Loewenich</dc:creator>
  <dc:description/>
  <dc:language>en-US</dc:language>
  <cp:lastModifiedBy>Friederike von Loewenich</cp:lastModifiedBy>
  <dcterms:modified xsi:type="dcterms:W3CDTF">2013-11-12T15:48:04Z</dcterms:modified>
  <cp:revision>5</cp:revision>
  <dc:subject/>
  <dc:title>Folie 1</dc:title>
</cp:coreProperties>
</file>